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13716000" cy="201168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F6BA65-27D7-86ED-47D5-35B0D43FF38A}" name="Kaynak, Ahmet (kaynakat)" initials="AK" userId="S::kaynakat@ucmail.uc.edu::e30822f5-f881-493f-bf88-3d523b0e27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97" autoAdjust="0"/>
    <p:restoredTop sz="94630"/>
  </p:normalViewPr>
  <p:slideViewPr>
    <p:cSldViewPr snapToGrid="0">
      <p:cViewPr varScale="1">
        <p:scale>
          <a:sx n="53" d="100"/>
          <a:sy n="53" d="100"/>
        </p:scale>
        <p:origin x="428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3D829013-813C-4699-9461-67F7B346B52D}"/>
    <pc:docChg chg="undo custSel modSld">
      <pc:chgData name="Kaynak, Ahmet (kaynakat)" userId="e30822f5-f881-493f-bf88-3d523b0e27a6" providerId="ADAL" clId="{3D829013-813C-4699-9461-67F7B346B52D}" dt="2025-03-28T17:59:46.294" v="64" actId="13926"/>
      <pc:docMkLst>
        <pc:docMk/>
      </pc:docMkLst>
      <pc:sldChg chg="modSp mod">
        <pc:chgData name="Kaynak, Ahmet (kaynakat)" userId="e30822f5-f881-493f-bf88-3d523b0e27a6" providerId="ADAL" clId="{3D829013-813C-4699-9461-67F7B346B52D}" dt="2025-03-28T17:59:46.294" v="64" actId="13926"/>
        <pc:sldMkLst>
          <pc:docMk/>
          <pc:sldMk cId="2321588582" sldId="256"/>
        </pc:sldMkLst>
        <pc:spChg chg="mod">
          <ac:chgData name="Kaynak, Ahmet (kaynakat)" userId="e30822f5-f881-493f-bf88-3d523b0e27a6" providerId="ADAL" clId="{3D829013-813C-4699-9461-67F7B346B52D}" dt="2025-03-28T17:59:46.294" v="64" actId="13926"/>
          <ac:spMkLst>
            <pc:docMk/>
            <pc:sldMk cId="2321588582" sldId="256"/>
            <ac:spMk id="8" creationId="{52A5DB6E-47F7-EE2F-A476-8AFE007C7A92}"/>
          </ac:spMkLst>
        </pc:spChg>
        <pc:spChg chg="mod">
          <ac:chgData name="Kaynak, Ahmet (kaynakat)" userId="e30822f5-f881-493f-bf88-3d523b0e27a6" providerId="ADAL" clId="{3D829013-813C-4699-9461-67F7B346B52D}" dt="2025-03-07T17:27:57.634" v="0" actId="1076"/>
          <ac:spMkLst>
            <pc:docMk/>
            <pc:sldMk cId="2321588582" sldId="256"/>
            <ac:spMk id="376" creationId="{210B52F8-801A-BDF4-D0D3-4AE5D7C4E09C}"/>
          </ac:spMkLst>
        </pc:spChg>
      </pc:sldChg>
    </pc:docChg>
  </pc:docChgLst>
  <pc:docChgLst>
    <pc:chgData name="Kaynak, Ahmet (kaynakat)" userId="e30822f5-f881-493f-bf88-3d523b0e27a6" providerId="ADAL" clId="{134EBF86-9A55-4051-B17D-0365AE3B3F1C}"/>
    <pc:docChg chg="undo redo custSel modSld">
      <pc:chgData name="Kaynak, Ahmet (kaynakat)" userId="e30822f5-f881-493f-bf88-3d523b0e27a6" providerId="ADAL" clId="{134EBF86-9A55-4051-B17D-0365AE3B3F1C}" dt="2025-02-13T15:16:36.993" v="627" actId="20577"/>
      <pc:docMkLst>
        <pc:docMk/>
      </pc:docMkLst>
      <pc:sldChg chg="addSp delSp modSp mod">
        <pc:chgData name="Kaynak, Ahmet (kaynakat)" userId="e30822f5-f881-493f-bf88-3d523b0e27a6" providerId="ADAL" clId="{134EBF86-9A55-4051-B17D-0365AE3B3F1C}" dt="2025-02-13T15:16:36.993" v="627" actId="20577"/>
        <pc:sldMkLst>
          <pc:docMk/>
          <pc:sldMk cId="2321588582" sldId="256"/>
        </pc:sldMkLst>
        <pc:spChg chg="mod">
          <ac:chgData name="Kaynak, Ahmet (kaynakat)" userId="e30822f5-f881-493f-bf88-3d523b0e27a6" providerId="ADAL" clId="{134EBF86-9A55-4051-B17D-0365AE3B3F1C}" dt="2025-02-13T15:16:36.993" v="627" actId="20577"/>
          <ac:spMkLst>
            <pc:docMk/>
            <pc:sldMk cId="2321588582" sldId="256"/>
            <ac:spMk id="8" creationId="{52A5DB6E-47F7-EE2F-A476-8AFE007C7A92}"/>
          </ac:spMkLst>
        </pc:spChg>
        <pc:spChg chg="mod">
          <ac:chgData name="Kaynak, Ahmet (kaynakat)" userId="e30822f5-f881-493f-bf88-3d523b0e27a6" providerId="ADAL" clId="{134EBF86-9A55-4051-B17D-0365AE3B3F1C}" dt="2025-02-13T15:08:49.860" v="460" actId="1037"/>
          <ac:spMkLst>
            <pc:docMk/>
            <pc:sldMk cId="2321588582" sldId="256"/>
            <ac:spMk id="14" creationId="{A6C26E30-4FF6-27B4-26E6-1E0EE3EE96F6}"/>
          </ac:spMkLst>
        </pc:spChg>
        <pc:spChg chg="mod">
          <ac:chgData name="Kaynak, Ahmet (kaynakat)" userId="e30822f5-f881-493f-bf88-3d523b0e27a6" providerId="ADAL" clId="{134EBF86-9A55-4051-B17D-0365AE3B3F1C}" dt="2025-02-13T15:08:49.860" v="460" actId="1037"/>
          <ac:spMkLst>
            <pc:docMk/>
            <pc:sldMk cId="2321588582" sldId="256"/>
            <ac:spMk id="18" creationId="{8F1B71D4-BD0C-9B15-75BF-62D2B2882854}"/>
          </ac:spMkLst>
        </pc:spChg>
        <pc:spChg chg="mod">
          <ac:chgData name="Kaynak, Ahmet (kaynakat)" userId="e30822f5-f881-493f-bf88-3d523b0e27a6" providerId="ADAL" clId="{134EBF86-9A55-4051-B17D-0365AE3B3F1C}" dt="2025-02-13T15:08:49.860" v="460" actId="1037"/>
          <ac:spMkLst>
            <pc:docMk/>
            <pc:sldMk cId="2321588582" sldId="256"/>
            <ac:spMk id="25" creationId="{C714143F-0446-9167-C2E1-F198D411D046}"/>
          </ac:spMkLst>
        </pc:spChg>
        <pc:spChg chg="mod">
          <ac:chgData name="Kaynak, Ahmet (kaynakat)" userId="e30822f5-f881-493f-bf88-3d523b0e27a6" providerId="ADAL" clId="{134EBF86-9A55-4051-B17D-0365AE3B3F1C}" dt="2025-02-13T15:08:49.860" v="460" actId="1037"/>
          <ac:spMkLst>
            <pc:docMk/>
            <pc:sldMk cId="2321588582" sldId="256"/>
            <ac:spMk id="48" creationId="{2000AFCC-ECC0-231D-F6F7-DED07BAB2FDF}"/>
          </ac:spMkLst>
        </pc:spChg>
        <pc:spChg chg="mod">
          <ac:chgData name="Kaynak, Ahmet (kaynakat)" userId="e30822f5-f881-493f-bf88-3d523b0e27a6" providerId="ADAL" clId="{134EBF86-9A55-4051-B17D-0365AE3B3F1C}" dt="2025-02-13T15:08:49.860" v="460" actId="1037"/>
          <ac:spMkLst>
            <pc:docMk/>
            <pc:sldMk cId="2321588582" sldId="256"/>
            <ac:spMk id="59" creationId="{C1E86B56-C7E7-F10B-1C71-D567ED3556F0}"/>
          </ac:spMkLst>
        </pc:spChg>
        <pc:spChg chg="mod">
          <ac:chgData name="Kaynak, Ahmet (kaynakat)" userId="e30822f5-f881-493f-bf88-3d523b0e27a6" providerId="ADAL" clId="{134EBF86-9A55-4051-B17D-0365AE3B3F1C}" dt="2025-02-13T15:10:18.475" v="489" actId="1036"/>
          <ac:spMkLst>
            <pc:docMk/>
            <pc:sldMk cId="2321588582" sldId="256"/>
            <ac:spMk id="60" creationId="{7C17EC77-F7B0-3056-474E-66E6928B9E63}"/>
          </ac:spMkLst>
        </pc:spChg>
        <pc:spChg chg="mod">
          <ac:chgData name="Kaynak, Ahmet (kaynakat)" userId="e30822f5-f881-493f-bf88-3d523b0e27a6" providerId="ADAL" clId="{134EBF86-9A55-4051-B17D-0365AE3B3F1C}" dt="2025-02-13T15:10:18.475" v="489" actId="1036"/>
          <ac:spMkLst>
            <pc:docMk/>
            <pc:sldMk cId="2321588582" sldId="256"/>
            <ac:spMk id="61" creationId="{1CBD0F6B-3EC0-46E3-6754-C282B7418BFD}"/>
          </ac:spMkLst>
        </pc:spChg>
        <pc:spChg chg="mod">
          <ac:chgData name="Kaynak, Ahmet (kaynakat)" userId="e30822f5-f881-493f-bf88-3d523b0e27a6" providerId="ADAL" clId="{134EBF86-9A55-4051-B17D-0365AE3B3F1C}" dt="2025-02-13T15:10:18.475" v="489" actId="1036"/>
          <ac:spMkLst>
            <pc:docMk/>
            <pc:sldMk cId="2321588582" sldId="256"/>
            <ac:spMk id="322" creationId="{0AFAFB8D-922A-0AAA-D808-68A67EBD052C}"/>
          </ac:spMkLst>
        </pc:spChg>
        <pc:spChg chg="mod">
          <ac:chgData name="Kaynak, Ahmet (kaynakat)" userId="e30822f5-f881-493f-bf88-3d523b0e27a6" providerId="ADAL" clId="{134EBF86-9A55-4051-B17D-0365AE3B3F1C}" dt="2025-02-13T15:10:18.475" v="489" actId="1036"/>
          <ac:spMkLst>
            <pc:docMk/>
            <pc:sldMk cId="2321588582" sldId="256"/>
            <ac:spMk id="323" creationId="{E3F5E977-BBAD-9AE4-4415-D3169BA8B09E}"/>
          </ac:spMkLst>
        </pc:spChg>
        <pc:spChg chg="mod">
          <ac:chgData name="Kaynak, Ahmet (kaynakat)" userId="e30822f5-f881-493f-bf88-3d523b0e27a6" providerId="ADAL" clId="{134EBF86-9A55-4051-B17D-0365AE3B3F1C}" dt="2025-02-13T15:10:35.299" v="545" actId="1036"/>
          <ac:spMkLst>
            <pc:docMk/>
            <pc:sldMk cId="2321588582" sldId="256"/>
            <ac:spMk id="324" creationId="{079AA01F-86F4-C35C-6E93-D96A116A65D2}"/>
          </ac:spMkLst>
        </pc:spChg>
        <pc:spChg chg="mod">
          <ac:chgData name="Kaynak, Ahmet (kaynakat)" userId="e30822f5-f881-493f-bf88-3d523b0e27a6" providerId="ADAL" clId="{134EBF86-9A55-4051-B17D-0365AE3B3F1C}" dt="2025-02-13T15:07:47.242" v="329" actId="255"/>
          <ac:spMkLst>
            <pc:docMk/>
            <pc:sldMk cId="2321588582" sldId="256"/>
            <ac:spMk id="325" creationId="{E9F11B55-53BF-2B19-1F14-76D335345472}"/>
          </ac:spMkLst>
        </pc:spChg>
        <pc:spChg chg="mod">
          <ac:chgData name="Kaynak, Ahmet (kaynakat)" userId="e30822f5-f881-493f-bf88-3d523b0e27a6" providerId="ADAL" clId="{134EBF86-9A55-4051-B17D-0365AE3B3F1C}" dt="2025-02-13T15:10:32.447" v="534" actId="1036"/>
          <ac:spMkLst>
            <pc:docMk/>
            <pc:sldMk cId="2321588582" sldId="256"/>
            <ac:spMk id="331" creationId="{243B73CA-F24E-6477-EF46-60E2274B2CB3}"/>
          </ac:spMkLst>
        </pc:spChg>
        <pc:spChg chg="mod">
          <ac:chgData name="Kaynak, Ahmet (kaynakat)" userId="e30822f5-f881-493f-bf88-3d523b0e27a6" providerId="ADAL" clId="{134EBF86-9A55-4051-B17D-0365AE3B3F1C}" dt="2025-02-13T15:07:47.242" v="329" actId="255"/>
          <ac:spMkLst>
            <pc:docMk/>
            <pc:sldMk cId="2321588582" sldId="256"/>
            <ac:spMk id="333" creationId="{18D59082-8C60-DC2D-757B-BCA83ECFC833}"/>
          </ac:spMkLst>
        </pc:spChg>
        <pc:spChg chg="mod">
          <ac:chgData name="Kaynak, Ahmet (kaynakat)" userId="e30822f5-f881-493f-bf88-3d523b0e27a6" providerId="ADAL" clId="{134EBF86-9A55-4051-B17D-0365AE3B3F1C}" dt="2025-02-13T15:10:29.787" v="522" actId="1036"/>
          <ac:spMkLst>
            <pc:docMk/>
            <pc:sldMk cId="2321588582" sldId="256"/>
            <ac:spMk id="352" creationId="{5E038C81-5DF4-0A74-187E-AB531B7E73BA}"/>
          </ac:spMkLst>
        </pc:spChg>
        <pc:spChg chg="mod">
          <ac:chgData name="Kaynak, Ahmet (kaynakat)" userId="e30822f5-f881-493f-bf88-3d523b0e27a6" providerId="ADAL" clId="{134EBF86-9A55-4051-B17D-0365AE3B3F1C}" dt="2025-02-13T15:07:47.242" v="329" actId="255"/>
          <ac:spMkLst>
            <pc:docMk/>
            <pc:sldMk cId="2321588582" sldId="256"/>
            <ac:spMk id="353" creationId="{2E34F04B-4F72-08BC-F652-71347508AE5E}"/>
          </ac:spMkLst>
        </pc:spChg>
        <pc:spChg chg="mod">
          <ac:chgData name="Kaynak, Ahmet (kaynakat)" userId="e30822f5-f881-493f-bf88-3d523b0e27a6" providerId="ADAL" clId="{134EBF86-9A55-4051-B17D-0365AE3B3F1C}" dt="2025-02-13T15:10:27.973" v="515" actId="1036"/>
          <ac:spMkLst>
            <pc:docMk/>
            <pc:sldMk cId="2321588582" sldId="256"/>
            <ac:spMk id="358" creationId="{A596141F-2EB9-5E76-23B4-D798ECC924F9}"/>
          </ac:spMkLst>
        </pc:spChg>
        <pc:spChg chg="mod">
          <ac:chgData name="Kaynak, Ahmet (kaynakat)" userId="e30822f5-f881-493f-bf88-3d523b0e27a6" providerId="ADAL" clId="{134EBF86-9A55-4051-B17D-0365AE3B3F1C}" dt="2025-02-13T15:07:58.326" v="346" actId="1038"/>
          <ac:spMkLst>
            <pc:docMk/>
            <pc:sldMk cId="2321588582" sldId="256"/>
            <ac:spMk id="370" creationId="{2326590C-7CE1-4AF4-B92B-03B2C7E05B42}"/>
          </ac:spMkLst>
        </pc:spChg>
        <pc:spChg chg="mod">
          <ac:chgData name="Kaynak, Ahmet (kaynakat)" userId="e30822f5-f881-493f-bf88-3d523b0e27a6" providerId="ADAL" clId="{134EBF86-9A55-4051-B17D-0365AE3B3F1C}" dt="2025-02-13T15:08:02.717" v="366" actId="1036"/>
          <ac:spMkLst>
            <pc:docMk/>
            <pc:sldMk cId="2321588582" sldId="256"/>
            <ac:spMk id="371" creationId="{45135696-F42C-BC0D-BADF-B296DB8E9AEC}"/>
          </ac:spMkLst>
        </pc:spChg>
        <pc:spChg chg="mod">
          <ac:chgData name="Kaynak, Ahmet (kaynakat)" userId="e30822f5-f881-493f-bf88-3d523b0e27a6" providerId="ADAL" clId="{134EBF86-9A55-4051-B17D-0365AE3B3F1C}" dt="2025-02-13T15:08:08.708" v="400" actId="1037"/>
          <ac:spMkLst>
            <pc:docMk/>
            <pc:sldMk cId="2321588582" sldId="256"/>
            <ac:spMk id="372" creationId="{D51274A5-C4ED-843F-6ED0-EA466F7BD039}"/>
          </ac:spMkLst>
        </pc:spChg>
        <pc:spChg chg="mod">
          <ac:chgData name="Kaynak, Ahmet (kaynakat)" userId="e30822f5-f881-493f-bf88-3d523b0e27a6" providerId="ADAL" clId="{134EBF86-9A55-4051-B17D-0365AE3B3F1C}" dt="2025-02-13T15:08:12.876" v="415" actId="1038"/>
          <ac:spMkLst>
            <pc:docMk/>
            <pc:sldMk cId="2321588582" sldId="256"/>
            <ac:spMk id="373" creationId="{1BEC3238-936B-73B7-36A6-57BA2D27F68C}"/>
          </ac:spMkLst>
        </pc:spChg>
        <pc:spChg chg="mod">
          <ac:chgData name="Kaynak, Ahmet (kaynakat)" userId="e30822f5-f881-493f-bf88-3d523b0e27a6" providerId="ADAL" clId="{134EBF86-9A55-4051-B17D-0365AE3B3F1C}" dt="2025-02-13T15:10:25.078" v="504" actId="1036"/>
          <ac:spMkLst>
            <pc:docMk/>
            <pc:sldMk cId="2321588582" sldId="256"/>
            <ac:spMk id="376" creationId="{210B52F8-801A-BDF4-D0D3-4AE5D7C4E09C}"/>
          </ac:spMkLst>
        </pc:spChg>
        <pc:spChg chg="mod">
          <ac:chgData name="Kaynak, Ahmet (kaynakat)" userId="e30822f5-f881-493f-bf88-3d523b0e27a6" providerId="ADAL" clId="{134EBF86-9A55-4051-B17D-0365AE3B3F1C}" dt="2025-02-13T15:07:47.242" v="329" actId="255"/>
          <ac:spMkLst>
            <pc:docMk/>
            <pc:sldMk cId="2321588582" sldId="256"/>
            <ac:spMk id="377" creationId="{7F1F48E1-1D6F-6254-3FCB-FBF3D85A0E3B}"/>
          </ac:spMkLst>
        </pc:spChg>
        <pc:spChg chg="mod">
          <ac:chgData name="Kaynak, Ahmet (kaynakat)" userId="e30822f5-f881-493f-bf88-3d523b0e27a6" providerId="ADAL" clId="{134EBF86-9A55-4051-B17D-0365AE3B3F1C}" dt="2025-02-13T15:08:16.828" v="431" actId="1038"/>
          <ac:spMkLst>
            <pc:docMk/>
            <pc:sldMk cId="2321588582" sldId="256"/>
            <ac:spMk id="378" creationId="{1BDB47E5-94D9-EDB0-810A-C203AB4AE1B2}"/>
          </ac:spMkLst>
        </pc:spChg>
        <pc:grpChg chg="mod">
          <ac:chgData name="Kaynak, Ahmet (kaynakat)" userId="e30822f5-f881-493f-bf88-3d523b0e27a6" providerId="ADAL" clId="{134EBF86-9A55-4051-B17D-0365AE3B3F1C}" dt="2025-02-13T15:07:12.654" v="321" actId="1076"/>
          <ac:grpSpMkLst>
            <pc:docMk/>
            <pc:sldMk cId="2321588582" sldId="256"/>
            <ac:grpSpMk id="2" creationId="{0D74361D-8459-10E1-0D23-28FD66AF40AD}"/>
          </ac:grpSpMkLst>
        </pc:grpChg>
      </pc:sldChg>
    </pc:docChg>
  </pc:docChgLst>
  <pc:docChgLst>
    <pc:chgData name="Kaynak, Ahmet (kaynakat)" userId="e30822f5-f881-493f-bf88-3d523b0e27a6" providerId="ADAL" clId="{3410347F-E8B7-41AA-BC76-E42A5A2F1591}"/>
    <pc:docChg chg="custSel delSld modSld">
      <pc:chgData name="Kaynak, Ahmet (kaynakat)" userId="e30822f5-f881-493f-bf88-3d523b0e27a6" providerId="ADAL" clId="{3410347F-E8B7-41AA-BC76-E42A5A2F1591}" dt="2025-01-22T23:20:48.772" v="1" actId="47"/>
      <pc:docMkLst>
        <pc:docMk/>
      </pc:docMkLst>
      <pc:sldChg chg="delSp del mod">
        <pc:chgData name="Kaynak, Ahmet (kaynakat)" userId="e30822f5-f881-493f-bf88-3d523b0e27a6" providerId="ADAL" clId="{3410347F-E8B7-41AA-BC76-E42A5A2F1591}" dt="2025-01-22T23:20:48.772" v="1" actId="47"/>
        <pc:sldMkLst>
          <pc:docMk/>
          <pc:sldMk cId="727579023" sldId="25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9880CF3-FDA2-4B89-AED2-455CAC02616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35225" y="1162050"/>
            <a:ext cx="213995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8CE92EE-02C9-424A-AD7D-2D3AF1FB3C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042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1pPr>
    <a:lvl2pPr marL="767943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2pPr>
    <a:lvl3pPr marL="1535886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3pPr>
    <a:lvl4pPr marL="2303826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4pPr>
    <a:lvl5pPr marL="3071769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5pPr>
    <a:lvl6pPr marL="3839712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6pPr>
    <a:lvl7pPr marL="4607655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7pPr>
    <a:lvl8pPr marL="5375597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8pPr>
    <a:lvl9pPr marL="6143540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CE92EE-02C9-424A-AD7D-2D3AF1FB3CA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58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3292265"/>
            <a:ext cx="11658600" cy="7003627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10565978"/>
            <a:ext cx="10287000" cy="4856902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726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944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1071033"/>
            <a:ext cx="2957513" cy="170480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1071033"/>
            <a:ext cx="8701088" cy="1704805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343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827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5015236"/>
            <a:ext cx="11830050" cy="8368029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13462429"/>
            <a:ext cx="11830050" cy="4400549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>
                    <a:tint val="82000"/>
                  </a:schemeClr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82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82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363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5355167"/>
            <a:ext cx="582930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5355167"/>
            <a:ext cx="582930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937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071038"/>
            <a:ext cx="11830050" cy="38883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4931411"/>
            <a:ext cx="5802510" cy="2416809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7348220"/>
            <a:ext cx="5802510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4931411"/>
            <a:ext cx="5831087" cy="2416809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7348220"/>
            <a:ext cx="5831087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642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452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967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341120"/>
            <a:ext cx="4423767" cy="46939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2896451"/>
            <a:ext cx="6943725" cy="14295967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6035040"/>
            <a:ext cx="4423767" cy="11180658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290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341120"/>
            <a:ext cx="4423767" cy="46939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2896451"/>
            <a:ext cx="6943725" cy="14295967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6035040"/>
            <a:ext cx="4423767" cy="11180658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613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1071038"/>
            <a:ext cx="11830050" cy="38883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5355167"/>
            <a:ext cx="11830050" cy="12763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8645298"/>
            <a:ext cx="308610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29E893-D5F9-405B-881F-368D8E78059C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8645298"/>
            <a:ext cx="462915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8645298"/>
            <a:ext cx="308610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252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TextBox 327">
            <a:extLst>
              <a:ext uri="{FF2B5EF4-FFF2-40B4-BE49-F238E27FC236}">
                <a16:creationId xmlns:a16="http://schemas.microsoft.com/office/drawing/2014/main" id="{7E28018A-A26D-9AE3-A4EA-29F2FB90DA46}"/>
              </a:ext>
            </a:extLst>
          </p:cNvPr>
          <p:cNvSpPr txBox="1"/>
          <p:nvPr/>
        </p:nvSpPr>
        <p:spPr>
          <a:xfrm>
            <a:off x="739681" y="78371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9471583E-3D69-7303-C8CF-7DB6D255EA56}"/>
              </a:ext>
            </a:extLst>
          </p:cNvPr>
          <p:cNvSpPr txBox="1"/>
          <p:nvPr/>
        </p:nvSpPr>
        <p:spPr>
          <a:xfrm>
            <a:off x="7172121" y="1060821"/>
            <a:ext cx="69404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70 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threonine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636 (pT636-Hsp70)</a:t>
            </a:r>
          </a:p>
        </p:txBody>
      </p:sp>
      <p:pic>
        <p:nvPicPr>
          <p:cNvPr id="337" name="Picture 336">
            <a:extLst>
              <a:ext uri="{FF2B5EF4-FFF2-40B4-BE49-F238E27FC236}">
                <a16:creationId xmlns:a16="http://schemas.microsoft.com/office/drawing/2014/main" id="{1A43FCD9-17B0-2094-0F08-83BEB2A0B3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37" t="30393" r="24786" b="43027"/>
          <a:stretch/>
        </p:blipFill>
        <p:spPr>
          <a:xfrm>
            <a:off x="963573" y="3358258"/>
            <a:ext cx="4461394" cy="2018149"/>
          </a:xfrm>
          <a:prstGeom prst="rect">
            <a:avLst/>
          </a:prstGeom>
        </p:spPr>
      </p:pic>
      <p:grpSp>
        <p:nvGrpSpPr>
          <p:cNvPr id="341" name="Group 340">
            <a:extLst>
              <a:ext uri="{FF2B5EF4-FFF2-40B4-BE49-F238E27FC236}">
                <a16:creationId xmlns:a16="http://schemas.microsoft.com/office/drawing/2014/main" id="{6CCA1AE6-4706-5030-3882-5A7CA5F66B16}"/>
              </a:ext>
            </a:extLst>
          </p:cNvPr>
          <p:cNvGrpSpPr/>
          <p:nvPr/>
        </p:nvGrpSpPr>
        <p:grpSpPr>
          <a:xfrm>
            <a:off x="574495" y="3321166"/>
            <a:ext cx="434901" cy="2007864"/>
            <a:chOff x="492583" y="1775110"/>
            <a:chExt cx="434901" cy="2007864"/>
          </a:xfrm>
        </p:grpSpPr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B353AD54-6E57-CA57-E8FF-947A19FC6618}"/>
                </a:ext>
              </a:extLst>
            </p:cNvPr>
            <p:cNvSpPr txBox="1"/>
            <p:nvPr/>
          </p:nvSpPr>
          <p:spPr>
            <a:xfrm>
              <a:off x="497558" y="1775110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50</a:t>
              </a:r>
            </a:p>
          </p:txBody>
        </p:sp>
        <p:sp>
          <p:nvSpPr>
            <p:cNvPr id="344" name="TextBox 343">
              <a:extLst>
                <a:ext uri="{FF2B5EF4-FFF2-40B4-BE49-F238E27FC236}">
                  <a16:creationId xmlns:a16="http://schemas.microsoft.com/office/drawing/2014/main" id="{7F4734B8-C340-8781-5BCB-983FE3B2DA19}"/>
                </a:ext>
              </a:extLst>
            </p:cNvPr>
            <p:cNvSpPr txBox="1"/>
            <p:nvPr/>
          </p:nvSpPr>
          <p:spPr>
            <a:xfrm>
              <a:off x="497558" y="2123361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50</a:t>
              </a:r>
            </a:p>
          </p:txBody>
        </p:sp>
        <p:sp>
          <p:nvSpPr>
            <p:cNvPr id="345" name="TextBox 344">
              <a:extLst>
                <a:ext uri="{FF2B5EF4-FFF2-40B4-BE49-F238E27FC236}">
                  <a16:creationId xmlns:a16="http://schemas.microsoft.com/office/drawing/2014/main" id="{9229E63E-94D9-5DDC-FC2F-94ABA414FD5D}"/>
                </a:ext>
              </a:extLst>
            </p:cNvPr>
            <p:cNvSpPr txBox="1"/>
            <p:nvPr/>
          </p:nvSpPr>
          <p:spPr>
            <a:xfrm>
              <a:off x="492583" y="2444123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00</a:t>
              </a:r>
            </a:p>
          </p:txBody>
        </p:sp>
        <p:sp>
          <p:nvSpPr>
            <p:cNvPr id="346" name="TextBox 345">
              <a:extLst>
                <a:ext uri="{FF2B5EF4-FFF2-40B4-BE49-F238E27FC236}">
                  <a16:creationId xmlns:a16="http://schemas.microsoft.com/office/drawing/2014/main" id="{ACE33CEC-DFE4-C3AD-A5DE-A89B36A450F1}"/>
                </a:ext>
              </a:extLst>
            </p:cNvPr>
            <p:cNvSpPr txBox="1"/>
            <p:nvPr/>
          </p:nvSpPr>
          <p:spPr>
            <a:xfrm>
              <a:off x="512933" y="2675009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75</a:t>
              </a:r>
            </a:p>
          </p:txBody>
        </p:sp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E3FE2399-90FF-7C5A-404E-C580DBB9F4A2}"/>
                </a:ext>
              </a:extLst>
            </p:cNvPr>
            <p:cNvSpPr txBox="1"/>
            <p:nvPr/>
          </p:nvSpPr>
          <p:spPr>
            <a:xfrm>
              <a:off x="545568" y="316675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50</a:t>
              </a:r>
            </a:p>
          </p:txBody>
        </p:sp>
        <p:sp>
          <p:nvSpPr>
            <p:cNvPr id="348" name="TextBox 347">
              <a:extLst>
                <a:ext uri="{FF2B5EF4-FFF2-40B4-BE49-F238E27FC236}">
                  <a16:creationId xmlns:a16="http://schemas.microsoft.com/office/drawing/2014/main" id="{6C7DCEBB-9624-B41F-68B5-A837A9880590}"/>
                </a:ext>
              </a:extLst>
            </p:cNvPr>
            <p:cNvSpPr txBox="1"/>
            <p:nvPr/>
          </p:nvSpPr>
          <p:spPr>
            <a:xfrm>
              <a:off x="545568" y="3505975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37</a:t>
              </a:r>
            </a:p>
          </p:txBody>
        </p:sp>
      </p:grpSp>
      <p:sp>
        <p:nvSpPr>
          <p:cNvPr id="342" name="Rectangle 341">
            <a:extLst>
              <a:ext uri="{FF2B5EF4-FFF2-40B4-BE49-F238E27FC236}">
                <a16:creationId xmlns:a16="http://schemas.microsoft.com/office/drawing/2014/main" id="{1CC71A79-810E-27E5-3221-D42A0E79F0DD}"/>
              </a:ext>
            </a:extLst>
          </p:cNvPr>
          <p:cNvSpPr/>
          <p:nvPr/>
        </p:nvSpPr>
        <p:spPr>
          <a:xfrm>
            <a:off x="1756669" y="4215178"/>
            <a:ext cx="2819324" cy="23772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Isosceles Triangle 333">
            <a:extLst>
              <a:ext uri="{FF2B5EF4-FFF2-40B4-BE49-F238E27FC236}">
                <a16:creationId xmlns:a16="http://schemas.microsoft.com/office/drawing/2014/main" id="{23EE51F0-3DDE-83C6-AEE8-563DF860E684}"/>
              </a:ext>
            </a:extLst>
          </p:cNvPr>
          <p:cNvSpPr/>
          <p:nvPr/>
        </p:nvSpPr>
        <p:spPr>
          <a:xfrm rot="16373579">
            <a:off x="5562708" y="4333002"/>
            <a:ext cx="130686" cy="178516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/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4E29F13E-CCE3-5162-D8B2-28F0E3AACA38}"/>
              </a:ext>
            </a:extLst>
          </p:cNvPr>
          <p:cNvSpPr txBox="1"/>
          <p:nvPr/>
        </p:nvSpPr>
        <p:spPr>
          <a:xfrm>
            <a:off x="5712627" y="4294976"/>
            <a:ext cx="119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0 </a:t>
            </a:r>
            <a:r>
              <a:rPr lang="en-US" sz="1200" b="1" dirty="0" err="1"/>
              <a:t>kDa</a:t>
            </a:r>
            <a:endParaRPr lang="en-US" sz="1200" b="1" dirty="0"/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B59C7209-C774-E96D-8BA2-0EFAEBA067EE}"/>
              </a:ext>
            </a:extLst>
          </p:cNvPr>
          <p:cNvSpPr txBox="1"/>
          <p:nvPr/>
        </p:nvSpPr>
        <p:spPr>
          <a:xfrm>
            <a:off x="1304897" y="1035087"/>
            <a:ext cx="52858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 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tyrosine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an-</a:t>
            </a:r>
            <a:r>
              <a:rPr lang="en-US" sz="2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351" name="Group 350">
            <a:extLst>
              <a:ext uri="{FF2B5EF4-FFF2-40B4-BE49-F238E27FC236}">
                <a16:creationId xmlns:a16="http://schemas.microsoft.com/office/drawing/2014/main" id="{8F6D2E64-72A9-7FD9-8E1D-E20AED530449}"/>
              </a:ext>
            </a:extLst>
          </p:cNvPr>
          <p:cNvGrpSpPr/>
          <p:nvPr/>
        </p:nvGrpSpPr>
        <p:grpSpPr>
          <a:xfrm>
            <a:off x="7236741" y="3247062"/>
            <a:ext cx="4787665" cy="2106420"/>
            <a:chOff x="3066753" y="9591739"/>
            <a:chExt cx="4787665" cy="2106420"/>
          </a:xfrm>
        </p:grpSpPr>
        <p:pic>
          <p:nvPicPr>
            <p:cNvPr id="359" name="Picture 358" descr="A close-up of a black and white photo&#10;&#10;Description automatically generated">
              <a:extLst>
                <a:ext uri="{FF2B5EF4-FFF2-40B4-BE49-F238E27FC236}">
                  <a16:creationId xmlns:a16="http://schemas.microsoft.com/office/drawing/2014/main" id="{84335647-6494-67F0-B342-6C97AB054DD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27" r="2103" b="4868"/>
            <a:stretch/>
          </p:blipFill>
          <p:spPr>
            <a:xfrm>
              <a:off x="3486881" y="9709274"/>
              <a:ext cx="4367537" cy="1988885"/>
            </a:xfrm>
            <a:prstGeom prst="rect">
              <a:avLst/>
            </a:prstGeom>
          </p:spPr>
        </p:pic>
        <p:grpSp>
          <p:nvGrpSpPr>
            <p:cNvPr id="360" name="Group 359">
              <a:extLst>
                <a:ext uri="{FF2B5EF4-FFF2-40B4-BE49-F238E27FC236}">
                  <a16:creationId xmlns:a16="http://schemas.microsoft.com/office/drawing/2014/main" id="{5654E044-37F0-A427-2272-9DEBC83D1031}"/>
                </a:ext>
              </a:extLst>
            </p:cNvPr>
            <p:cNvGrpSpPr/>
            <p:nvPr/>
          </p:nvGrpSpPr>
          <p:grpSpPr>
            <a:xfrm>
              <a:off x="3066753" y="9591739"/>
              <a:ext cx="434901" cy="2007864"/>
              <a:chOff x="492583" y="1775110"/>
              <a:chExt cx="434901" cy="2007864"/>
            </a:xfrm>
          </p:grpSpPr>
          <p:sp>
            <p:nvSpPr>
              <p:cNvPr id="361" name="TextBox 360">
                <a:extLst>
                  <a:ext uri="{FF2B5EF4-FFF2-40B4-BE49-F238E27FC236}">
                    <a16:creationId xmlns:a16="http://schemas.microsoft.com/office/drawing/2014/main" id="{0319E147-225B-F800-2BFB-AC487AEDFAB8}"/>
                  </a:ext>
                </a:extLst>
              </p:cNvPr>
              <p:cNvSpPr txBox="1"/>
              <p:nvPr/>
            </p:nvSpPr>
            <p:spPr>
              <a:xfrm>
                <a:off x="497558" y="1775110"/>
                <a:ext cx="4299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50</a:t>
                </a:r>
              </a:p>
            </p:txBody>
          </p:sp>
          <p:sp>
            <p:nvSpPr>
              <p:cNvPr id="362" name="TextBox 361">
                <a:extLst>
                  <a:ext uri="{FF2B5EF4-FFF2-40B4-BE49-F238E27FC236}">
                    <a16:creationId xmlns:a16="http://schemas.microsoft.com/office/drawing/2014/main" id="{3BA28D1B-527A-DD62-5B29-A3384C4678D8}"/>
                  </a:ext>
                </a:extLst>
              </p:cNvPr>
              <p:cNvSpPr txBox="1"/>
              <p:nvPr/>
            </p:nvSpPr>
            <p:spPr>
              <a:xfrm>
                <a:off x="497558" y="2123361"/>
                <a:ext cx="4299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50</a:t>
                </a:r>
              </a:p>
            </p:txBody>
          </p:sp>
          <p:sp>
            <p:nvSpPr>
              <p:cNvPr id="363" name="TextBox 362">
                <a:extLst>
                  <a:ext uri="{FF2B5EF4-FFF2-40B4-BE49-F238E27FC236}">
                    <a16:creationId xmlns:a16="http://schemas.microsoft.com/office/drawing/2014/main" id="{4D9B1FED-77FE-C987-640D-309735E333C6}"/>
                  </a:ext>
                </a:extLst>
              </p:cNvPr>
              <p:cNvSpPr txBox="1"/>
              <p:nvPr/>
            </p:nvSpPr>
            <p:spPr>
              <a:xfrm>
                <a:off x="492583" y="2444123"/>
                <a:ext cx="4299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0</a:t>
                </a:r>
              </a:p>
            </p:txBody>
          </p:sp>
          <p:sp>
            <p:nvSpPr>
              <p:cNvPr id="364" name="TextBox 363">
                <a:extLst>
                  <a:ext uri="{FF2B5EF4-FFF2-40B4-BE49-F238E27FC236}">
                    <a16:creationId xmlns:a16="http://schemas.microsoft.com/office/drawing/2014/main" id="{1C5CD2F6-76C2-70E8-ECD3-753B8F603D20}"/>
                  </a:ext>
                </a:extLst>
              </p:cNvPr>
              <p:cNvSpPr txBox="1"/>
              <p:nvPr/>
            </p:nvSpPr>
            <p:spPr>
              <a:xfrm>
                <a:off x="512933" y="2675009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75</a:t>
                </a:r>
              </a:p>
            </p:txBody>
          </p:sp>
          <p:sp>
            <p:nvSpPr>
              <p:cNvPr id="365" name="TextBox 364">
                <a:extLst>
                  <a:ext uri="{FF2B5EF4-FFF2-40B4-BE49-F238E27FC236}">
                    <a16:creationId xmlns:a16="http://schemas.microsoft.com/office/drawing/2014/main" id="{28330600-8483-E5B5-859A-D0C92A75117D}"/>
                  </a:ext>
                </a:extLst>
              </p:cNvPr>
              <p:cNvSpPr txBox="1"/>
              <p:nvPr/>
            </p:nvSpPr>
            <p:spPr>
              <a:xfrm>
                <a:off x="545568" y="3166750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50</a:t>
                </a:r>
              </a:p>
            </p:txBody>
          </p:sp>
          <p:sp>
            <p:nvSpPr>
              <p:cNvPr id="366" name="TextBox 365">
                <a:extLst>
                  <a:ext uri="{FF2B5EF4-FFF2-40B4-BE49-F238E27FC236}">
                    <a16:creationId xmlns:a16="http://schemas.microsoft.com/office/drawing/2014/main" id="{122D17D9-FAD3-4FEC-337A-47A2A58AA823}"/>
                  </a:ext>
                </a:extLst>
              </p:cNvPr>
              <p:cNvSpPr txBox="1"/>
              <p:nvPr/>
            </p:nvSpPr>
            <p:spPr>
              <a:xfrm>
                <a:off x="545568" y="3505975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7</a:t>
                </a:r>
              </a:p>
            </p:txBody>
          </p:sp>
        </p:grpSp>
      </p:grpSp>
      <p:sp>
        <p:nvSpPr>
          <p:cNvPr id="356" name="Isosceles Triangle 355">
            <a:extLst>
              <a:ext uri="{FF2B5EF4-FFF2-40B4-BE49-F238E27FC236}">
                <a16:creationId xmlns:a16="http://schemas.microsoft.com/office/drawing/2014/main" id="{5F8B81CF-1754-E678-1190-124454E3A136}"/>
              </a:ext>
            </a:extLst>
          </p:cNvPr>
          <p:cNvSpPr/>
          <p:nvPr/>
        </p:nvSpPr>
        <p:spPr>
          <a:xfrm rot="16373579">
            <a:off x="12124644" y="4261460"/>
            <a:ext cx="130686" cy="178516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/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528AAA64-CEBE-5658-C317-D832104BC1DA}"/>
              </a:ext>
            </a:extLst>
          </p:cNvPr>
          <p:cNvSpPr txBox="1"/>
          <p:nvPr/>
        </p:nvSpPr>
        <p:spPr>
          <a:xfrm>
            <a:off x="12274563" y="4223434"/>
            <a:ext cx="1191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0 </a:t>
            </a:r>
            <a:r>
              <a:rPr lang="en-US" sz="1200" b="1" dirty="0" err="1"/>
              <a:t>kDa</a:t>
            </a:r>
            <a:endParaRPr lang="en-US" sz="12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DE87266-A325-9A74-C620-0556C1EADBE4}"/>
              </a:ext>
            </a:extLst>
          </p:cNvPr>
          <p:cNvSpPr txBox="1"/>
          <p:nvPr/>
        </p:nvSpPr>
        <p:spPr>
          <a:xfrm>
            <a:off x="892081" y="6964385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A5DB6E-47F7-EE2F-A476-8AFE007C7A92}"/>
              </a:ext>
            </a:extLst>
          </p:cNvPr>
          <p:cNvSpPr txBox="1"/>
          <p:nvPr/>
        </p:nvSpPr>
        <p:spPr>
          <a:xfrm>
            <a:off x="768931" y="12961830"/>
            <a:ext cx="12172391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estern blotting evaluation of pT636-Hsp70, Hsp70, Pan-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y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Arginase1, TGM2,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NOS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SOCS3 and Actin in cancer cells and cancer cell-secreted EMD-CM. 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H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 Western blotting was performed using an anti-Pan-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Y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ntibody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anta Cruz Biotechnology, TX) 1:1000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and the anti-pT636-Hsp70 antibody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 gift from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ivoj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jtesek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etr Muller) 1:300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Results confirmed the expression of threonine 636 and tyrosine phosphorylated Hsp70 in both cell lysates and cancer cell-secreted EMD-CMs. (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 Western blot analyses of J774 cell lysates made from cells cultured for 24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hrs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with the EMD-CMs from indicated cancer cell lines probed with anti-arginase-1 (Santa Cruz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iotechnology,TX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 1:1000, anti-TGM2 (Santa Cruz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iotechnology,TX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 1:1000, anti-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NOS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(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eBioscience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CA) 1:1000, anti-SOCS3 and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actin (Cell Signaling Technology, MA) 1:1000 as a housekeeping protein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Results confirmed that J774 MØ cells treated with the EMD-CMs from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S</a:t>
            </a:r>
            <a:r>
              <a:rPr lang="en-US" sz="1800" b="0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high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cells (Gli36 and LLC-GFP) showed marked increases in the M2 polarization markers, arginase1 and TGM2, with corresponding decreases in the M1 markers NOS2, and SOCS3, compared to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S</a:t>
            </a:r>
            <a:r>
              <a:rPr lang="en-US" sz="1800" b="0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low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cells (A2058, AsPC-1, H1299)</a:t>
            </a:r>
            <a:endParaRPr lang="en-US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3B18AE05-5D8C-F6B9-3CE9-4A6FDB727DDD}"/>
              </a:ext>
            </a:extLst>
          </p:cNvPr>
          <p:cNvGrpSpPr/>
          <p:nvPr/>
        </p:nvGrpSpPr>
        <p:grpSpPr>
          <a:xfrm>
            <a:off x="1712450" y="1714447"/>
            <a:ext cx="2968948" cy="1600694"/>
            <a:chOff x="1712450" y="1714447"/>
            <a:chExt cx="2968948" cy="1600694"/>
          </a:xfrm>
        </p:grpSpPr>
        <p:sp>
          <p:nvSpPr>
            <p:cNvPr id="335" name="TextBox 334">
              <a:extLst>
                <a:ext uri="{FF2B5EF4-FFF2-40B4-BE49-F238E27FC236}">
                  <a16:creationId xmlns:a16="http://schemas.microsoft.com/office/drawing/2014/main" id="{8F263817-2B7A-EC65-785E-2D7095F1D73B}"/>
                </a:ext>
              </a:extLst>
            </p:cNvPr>
            <p:cNvSpPr txBox="1"/>
            <p:nvPr/>
          </p:nvSpPr>
          <p:spPr>
            <a:xfrm rot="16200000">
              <a:off x="3159968" y="2740745"/>
              <a:ext cx="964125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fPac1- Luc</a:t>
              </a: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13A2A39A-B799-161E-5486-FAD2AC075A9B}"/>
                </a:ext>
              </a:extLst>
            </p:cNvPr>
            <p:cNvSpPr txBox="1"/>
            <p:nvPr/>
          </p:nvSpPr>
          <p:spPr>
            <a:xfrm rot="16200000">
              <a:off x="3137224" y="3034455"/>
              <a:ext cx="376706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li36</a:t>
              </a: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27387CD1-A798-89E7-0D87-6B716D30E95A}"/>
                </a:ext>
              </a:extLst>
            </p:cNvPr>
            <p:cNvSpPr txBox="1"/>
            <p:nvPr/>
          </p:nvSpPr>
          <p:spPr>
            <a:xfrm rot="16200000">
              <a:off x="4151950" y="3040065"/>
              <a:ext cx="36548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373</a:t>
              </a:r>
            </a:p>
          </p:txBody>
        </p: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5D2E27EF-D02E-735C-63A5-7493CC63A426}"/>
                </a:ext>
              </a:extLst>
            </p:cNvPr>
            <p:cNvSpPr txBox="1"/>
            <p:nvPr/>
          </p:nvSpPr>
          <p:spPr>
            <a:xfrm rot="16200000">
              <a:off x="3601314" y="2828469"/>
              <a:ext cx="788677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LC-GGFP</a:t>
              </a:r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id="{26FB95E2-F134-C918-E07B-1423769BBCD8}"/>
                </a:ext>
              </a:extLst>
            </p:cNvPr>
            <p:cNvSpPr txBox="1"/>
            <p:nvPr/>
          </p:nvSpPr>
          <p:spPr>
            <a:xfrm>
              <a:off x="3663859" y="1717728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 defTabSz="1219246">
                <a:defRPr/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S</a:t>
              </a:r>
              <a:r>
                <a:rPr lang="en-US" sz="14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Right Bracket 379">
              <a:extLst>
                <a:ext uri="{FF2B5EF4-FFF2-40B4-BE49-F238E27FC236}">
                  <a16:creationId xmlns:a16="http://schemas.microsoft.com/office/drawing/2014/main" id="{461E27F2-0FA9-CB10-ACA5-81B8934DABBF}"/>
                </a:ext>
              </a:extLst>
            </p:cNvPr>
            <p:cNvSpPr/>
            <p:nvPr/>
          </p:nvSpPr>
          <p:spPr>
            <a:xfrm rot="5400000" flipH="1">
              <a:off x="3934257" y="1338751"/>
              <a:ext cx="57612" cy="1436671"/>
            </a:xfrm>
            <a:prstGeom prst="rightBracket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just"/>
              <a:endParaRPr 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A44F03E-B8CE-13B0-9DA5-F1F75D041868}"/>
                </a:ext>
              </a:extLst>
            </p:cNvPr>
            <p:cNvSpPr txBox="1"/>
            <p:nvPr/>
          </p:nvSpPr>
          <p:spPr>
            <a:xfrm rot="16200000">
              <a:off x="2753725" y="2997586"/>
              <a:ext cx="45044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2058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139C857-3299-01F8-3A14-69FED90195B3}"/>
                </a:ext>
              </a:extLst>
            </p:cNvPr>
            <p:cNvSpPr txBox="1"/>
            <p:nvPr/>
          </p:nvSpPr>
          <p:spPr>
            <a:xfrm rot="16200000">
              <a:off x="2397636" y="2950297"/>
              <a:ext cx="545021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PC-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51222CE-1DD3-3F59-97A2-BADF7376DDFF}"/>
                </a:ext>
              </a:extLst>
            </p:cNvPr>
            <p:cNvSpPr txBox="1"/>
            <p:nvPr/>
          </p:nvSpPr>
          <p:spPr>
            <a:xfrm rot="16200000">
              <a:off x="2113232" y="2997586"/>
              <a:ext cx="45044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16BEF1E-A042-6F6E-3CA8-7E09D3365851}"/>
                </a:ext>
              </a:extLst>
            </p:cNvPr>
            <p:cNvSpPr txBox="1"/>
            <p:nvPr/>
          </p:nvSpPr>
          <p:spPr>
            <a:xfrm rot="16200000">
              <a:off x="1689155" y="2869345"/>
              <a:ext cx="70692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trocyte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E5E1FF1-F4C8-3CDD-BC0A-C38184A1E70D}"/>
                </a:ext>
              </a:extLst>
            </p:cNvPr>
            <p:cNvSpPr txBox="1"/>
            <p:nvPr/>
          </p:nvSpPr>
          <p:spPr>
            <a:xfrm>
              <a:off x="2145207" y="1714447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 defTabSz="1219246">
                <a:defRPr/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S</a:t>
              </a:r>
              <a:r>
                <a:rPr lang="en-US" sz="14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ight Bracket 38">
              <a:extLst>
                <a:ext uri="{FF2B5EF4-FFF2-40B4-BE49-F238E27FC236}">
                  <a16:creationId xmlns:a16="http://schemas.microsoft.com/office/drawing/2014/main" id="{FD68FB11-0E8C-C33F-516A-9E5EB5ED5D8C}"/>
                </a:ext>
              </a:extLst>
            </p:cNvPr>
            <p:cNvSpPr/>
            <p:nvPr/>
          </p:nvSpPr>
          <p:spPr>
            <a:xfrm rot="5400000" flipH="1">
              <a:off x="2401980" y="1335470"/>
              <a:ext cx="57612" cy="1436671"/>
            </a:xfrm>
            <a:prstGeom prst="rightBracket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just"/>
              <a:endParaRPr 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D463DBD0-7167-5114-C4CD-A7D3BF7082F5}"/>
              </a:ext>
            </a:extLst>
          </p:cNvPr>
          <p:cNvGrpSpPr/>
          <p:nvPr/>
        </p:nvGrpSpPr>
        <p:grpSpPr>
          <a:xfrm>
            <a:off x="8293009" y="1667138"/>
            <a:ext cx="2968948" cy="1600694"/>
            <a:chOff x="1712450" y="1714447"/>
            <a:chExt cx="2968948" cy="1600694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820D78B-0960-13A6-43F4-18306781669A}"/>
                </a:ext>
              </a:extLst>
            </p:cNvPr>
            <p:cNvSpPr txBox="1"/>
            <p:nvPr/>
          </p:nvSpPr>
          <p:spPr>
            <a:xfrm rot="16200000">
              <a:off x="3159968" y="2740745"/>
              <a:ext cx="964125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fPac1- Luc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21D26DB-59B5-3875-F912-A6E241901304}"/>
                </a:ext>
              </a:extLst>
            </p:cNvPr>
            <p:cNvSpPr txBox="1"/>
            <p:nvPr/>
          </p:nvSpPr>
          <p:spPr>
            <a:xfrm rot="16200000">
              <a:off x="3137224" y="3034455"/>
              <a:ext cx="376706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li36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7B98797-E09A-84BD-852F-137740C5B09A}"/>
                </a:ext>
              </a:extLst>
            </p:cNvPr>
            <p:cNvSpPr txBox="1"/>
            <p:nvPr/>
          </p:nvSpPr>
          <p:spPr>
            <a:xfrm rot="16200000">
              <a:off x="4151950" y="3040065"/>
              <a:ext cx="36548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373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BE9DCA7-F529-FE56-8743-EAE70796C8F0}"/>
                </a:ext>
              </a:extLst>
            </p:cNvPr>
            <p:cNvSpPr txBox="1"/>
            <p:nvPr/>
          </p:nvSpPr>
          <p:spPr>
            <a:xfrm rot="16200000">
              <a:off x="3601314" y="2828469"/>
              <a:ext cx="788677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LC-GGFP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FE7FDFE-6188-E1A9-92E7-328DC8DA5F2D}"/>
                </a:ext>
              </a:extLst>
            </p:cNvPr>
            <p:cNvSpPr txBox="1"/>
            <p:nvPr/>
          </p:nvSpPr>
          <p:spPr>
            <a:xfrm>
              <a:off x="3663859" y="1717728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 defTabSz="1219246">
                <a:defRPr/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S</a:t>
              </a:r>
              <a:r>
                <a:rPr lang="en-US" sz="14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ight Bracket 50">
              <a:extLst>
                <a:ext uri="{FF2B5EF4-FFF2-40B4-BE49-F238E27FC236}">
                  <a16:creationId xmlns:a16="http://schemas.microsoft.com/office/drawing/2014/main" id="{5474929C-89CD-6CC6-2CEB-E8F531AE48DE}"/>
                </a:ext>
              </a:extLst>
            </p:cNvPr>
            <p:cNvSpPr/>
            <p:nvPr/>
          </p:nvSpPr>
          <p:spPr>
            <a:xfrm rot="5400000" flipH="1">
              <a:off x="3934257" y="1338751"/>
              <a:ext cx="57612" cy="1436671"/>
            </a:xfrm>
            <a:prstGeom prst="rightBracket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just"/>
              <a:endParaRPr 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A4B975D-5302-3BD1-3DA5-2A2710ABC91A}"/>
                </a:ext>
              </a:extLst>
            </p:cNvPr>
            <p:cNvSpPr txBox="1"/>
            <p:nvPr/>
          </p:nvSpPr>
          <p:spPr>
            <a:xfrm rot="16200000">
              <a:off x="2753725" y="2997586"/>
              <a:ext cx="45044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2058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F41EAEB-5B92-ECF4-D720-C6BA6D144826}"/>
                </a:ext>
              </a:extLst>
            </p:cNvPr>
            <p:cNvSpPr txBox="1"/>
            <p:nvPr/>
          </p:nvSpPr>
          <p:spPr>
            <a:xfrm rot="16200000">
              <a:off x="2397636" y="2950297"/>
              <a:ext cx="545021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PC-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C40EB26-3696-D84D-2868-5364395B0E72}"/>
                </a:ext>
              </a:extLst>
            </p:cNvPr>
            <p:cNvSpPr txBox="1"/>
            <p:nvPr/>
          </p:nvSpPr>
          <p:spPr>
            <a:xfrm rot="16200000">
              <a:off x="2113232" y="2997586"/>
              <a:ext cx="45044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0A4A04E-CDFF-3B8F-A0F9-555D0E182407}"/>
                </a:ext>
              </a:extLst>
            </p:cNvPr>
            <p:cNvSpPr txBox="1"/>
            <p:nvPr/>
          </p:nvSpPr>
          <p:spPr>
            <a:xfrm rot="16200000">
              <a:off x="1689155" y="2869345"/>
              <a:ext cx="70692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trocyte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F326E3F-5442-3674-8267-ED96F6E6D3A6}"/>
                </a:ext>
              </a:extLst>
            </p:cNvPr>
            <p:cNvSpPr txBox="1"/>
            <p:nvPr/>
          </p:nvSpPr>
          <p:spPr>
            <a:xfrm>
              <a:off x="2145207" y="1714447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 defTabSz="1219246">
                <a:defRPr/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S</a:t>
              </a:r>
              <a:r>
                <a:rPr lang="en-US" sz="14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ight Bracket 56">
              <a:extLst>
                <a:ext uri="{FF2B5EF4-FFF2-40B4-BE49-F238E27FC236}">
                  <a16:creationId xmlns:a16="http://schemas.microsoft.com/office/drawing/2014/main" id="{C3E18F7A-6EE4-C6CE-369A-94992C0C30FD}"/>
                </a:ext>
              </a:extLst>
            </p:cNvPr>
            <p:cNvSpPr/>
            <p:nvPr/>
          </p:nvSpPr>
          <p:spPr>
            <a:xfrm rot="5400000" flipH="1">
              <a:off x="2401980" y="1335470"/>
              <a:ext cx="57612" cy="1436671"/>
            </a:xfrm>
            <a:prstGeom prst="rightBracket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just"/>
              <a:endParaRPr 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Rectangle 57">
            <a:extLst>
              <a:ext uri="{FF2B5EF4-FFF2-40B4-BE49-F238E27FC236}">
                <a16:creationId xmlns:a16="http://schemas.microsoft.com/office/drawing/2014/main" id="{48AE5F71-98AC-8581-5437-40892DA4A2E7}"/>
              </a:ext>
            </a:extLst>
          </p:cNvPr>
          <p:cNvSpPr/>
          <p:nvPr/>
        </p:nvSpPr>
        <p:spPr>
          <a:xfrm>
            <a:off x="8320019" y="4157409"/>
            <a:ext cx="2819324" cy="23772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D74361D-8459-10E1-0D23-28FD66AF40AD}"/>
              </a:ext>
            </a:extLst>
          </p:cNvPr>
          <p:cNvGrpSpPr>
            <a:grpSpLocks noChangeAspect="1"/>
          </p:cNvGrpSpPr>
          <p:nvPr/>
        </p:nvGrpSpPr>
        <p:grpSpPr>
          <a:xfrm>
            <a:off x="4411692" y="7881036"/>
            <a:ext cx="4979641" cy="3985855"/>
            <a:chOff x="905664" y="12537450"/>
            <a:chExt cx="4749889" cy="380195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F4CA6F8-2329-7611-9C06-1E808C6C8AD4}"/>
                </a:ext>
              </a:extLst>
            </p:cNvPr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2" t="70007" r="68333" b="24730"/>
            <a:stretch/>
          </p:blipFill>
          <p:spPr bwMode="auto">
            <a:xfrm>
              <a:off x="1491729" y="13871209"/>
              <a:ext cx="2187360" cy="504552"/>
            </a:xfrm>
            <a:prstGeom prst="rect">
              <a:avLst/>
            </a:prstGeom>
            <a:noFill/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6C26E30-4FF6-27B4-26E6-1E0EE3EE96F6}"/>
                </a:ext>
              </a:extLst>
            </p:cNvPr>
            <p:cNvSpPr txBox="1"/>
            <p:nvPr/>
          </p:nvSpPr>
          <p:spPr>
            <a:xfrm rot="16200000">
              <a:off x="1847959" y="13366435"/>
              <a:ext cx="605806" cy="264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F1B71D4-BD0C-9B15-75BF-62D2B2882854}"/>
                </a:ext>
              </a:extLst>
            </p:cNvPr>
            <p:cNvSpPr txBox="1"/>
            <p:nvPr/>
          </p:nvSpPr>
          <p:spPr>
            <a:xfrm rot="16200000">
              <a:off x="1387316" y="13321328"/>
              <a:ext cx="696019" cy="264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PC-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714143F-0446-9167-C2E1-F198D411D046}"/>
                </a:ext>
              </a:extLst>
            </p:cNvPr>
            <p:cNvSpPr txBox="1"/>
            <p:nvPr/>
          </p:nvSpPr>
          <p:spPr>
            <a:xfrm rot="16200000">
              <a:off x="2283526" y="13366435"/>
              <a:ext cx="605806" cy="264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2058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000AFCC-ECC0-231D-F6F7-DED07BAB2FDF}"/>
                </a:ext>
              </a:extLst>
            </p:cNvPr>
            <p:cNvSpPr txBox="1"/>
            <p:nvPr/>
          </p:nvSpPr>
          <p:spPr>
            <a:xfrm rot="16200000">
              <a:off x="3108292" y="13262460"/>
              <a:ext cx="813756" cy="264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LC-GFP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1E86B56-C7E7-F10B-1C71-D567ED3556F0}"/>
                </a:ext>
              </a:extLst>
            </p:cNvPr>
            <p:cNvSpPr txBox="1"/>
            <p:nvPr/>
          </p:nvSpPr>
          <p:spPr>
            <a:xfrm rot="16200000">
              <a:off x="2769660" y="13401602"/>
              <a:ext cx="535470" cy="264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li36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C17EC77-F7B0-3056-474E-66E6928B9E63}"/>
                </a:ext>
              </a:extLst>
            </p:cNvPr>
            <p:cNvSpPr txBox="1"/>
            <p:nvPr/>
          </p:nvSpPr>
          <p:spPr>
            <a:xfrm>
              <a:off x="1866325" y="12560687"/>
              <a:ext cx="801610" cy="264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219139">
                <a:defRPr/>
              </a:pPr>
              <a:r>
                <a:rPr lang="en-US" sz="12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S</a:t>
              </a:r>
              <a:r>
                <a:rPr lang="en-US" sz="1200" b="1" baseline="300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ight Bracket 60">
              <a:extLst>
                <a:ext uri="{FF2B5EF4-FFF2-40B4-BE49-F238E27FC236}">
                  <a16:creationId xmlns:a16="http://schemas.microsoft.com/office/drawing/2014/main" id="{1CBD0F6B-3EC0-46E3-6754-C282B7418BFD}"/>
                </a:ext>
              </a:extLst>
            </p:cNvPr>
            <p:cNvSpPr/>
            <p:nvPr/>
          </p:nvSpPr>
          <p:spPr>
            <a:xfrm rot="16200000">
              <a:off x="2172381" y="12384250"/>
              <a:ext cx="73152" cy="1172376"/>
            </a:xfrm>
            <a:prstGeom prst="rightBracket">
              <a:avLst/>
            </a:prstGeom>
            <a:ln w="19050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0AFAFB8D-922A-0AAA-D808-68A67EBD052C}"/>
                </a:ext>
              </a:extLst>
            </p:cNvPr>
            <p:cNvSpPr txBox="1"/>
            <p:nvPr/>
          </p:nvSpPr>
          <p:spPr>
            <a:xfrm>
              <a:off x="2938161" y="12537450"/>
              <a:ext cx="578284" cy="264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219139">
                <a:defRPr/>
              </a:pPr>
              <a:r>
                <a:rPr lang="en-US" sz="12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S</a:t>
              </a:r>
              <a:r>
                <a:rPr lang="en-US" sz="1200" b="1" baseline="300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Right Bracket 322">
              <a:extLst>
                <a:ext uri="{FF2B5EF4-FFF2-40B4-BE49-F238E27FC236}">
                  <a16:creationId xmlns:a16="http://schemas.microsoft.com/office/drawing/2014/main" id="{E3F5E977-BBAD-9AE4-4415-D3169BA8B09E}"/>
                </a:ext>
              </a:extLst>
            </p:cNvPr>
            <p:cNvSpPr/>
            <p:nvPr/>
          </p:nvSpPr>
          <p:spPr>
            <a:xfrm rot="16200000">
              <a:off x="3213947" y="12557705"/>
              <a:ext cx="73152" cy="822960"/>
            </a:xfrm>
            <a:prstGeom prst="rightBracket">
              <a:avLst/>
            </a:prstGeom>
            <a:ln w="19050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079AA01F-86F4-C35C-6E93-D96A116A65D2}"/>
                </a:ext>
              </a:extLst>
            </p:cNvPr>
            <p:cNvSpPr txBox="1"/>
            <p:nvPr/>
          </p:nvSpPr>
          <p:spPr>
            <a:xfrm>
              <a:off x="3720828" y="14058703"/>
              <a:ext cx="1857477" cy="264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rginase1(M2)</a:t>
              </a:r>
            </a:p>
          </p:txBody>
        </p:sp>
        <p:sp>
          <p:nvSpPr>
            <p:cNvPr id="325" name="Rectangle 324">
              <a:extLst>
                <a:ext uri="{FF2B5EF4-FFF2-40B4-BE49-F238E27FC236}">
                  <a16:creationId xmlns:a16="http://schemas.microsoft.com/office/drawing/2014/main" id="{E9F11B55-53BF-2B19-1F14-76D335345472}"/>
                </a:ext>
              </a:extLst>
            </p:cNvPr>
            <p:cNvSpPr/>
            <p:nvPr/>
          </p:nvSpPr>
          <p:spPr>
            <a:xfrm>
              <a:off x="1492803" y="13878660"/>
              <a:ext cx="2182453" cy="500021"/>
            </a:xfrm>
            <a:prstGeom prst="rect">
              <a:avLst/>
            </a:prstGeom>
            <a:noFill/>
            <a:ln w="317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37867CE3-1639-9BF4-E86C-EF2FA210251F}"/>
                </a:ext>
              </a:extLst>
            </p:cNvPr>
            <p:cNvSpPr txBox="1"/>
            <p:nvPr/>
          </p:nvSpPr>
          <p:spPr>
            <a:xfrm>
              <a:off x="979520" y="13476568"/>
              <a:ext cx="443729" cy="264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7" name="Straight Connector 326">
              <a:extLst>
                <a:ext uri="{FF2B5EF4-FFF2-40B4-BE49-F238E27FC236}">
                  <a16:creationId xmlns:a16="http://schemas.microsoft.com/office/drawing/2014/main" id="{F4641332-CD0C-E4CE-4B86-C0C969B5C585}"/>
                </a:ext>
              </a:extLst>
            </p:cNvPr>
            <p:cNvCxnSpPr>
              <a:cxnSpLocks/>
            </p:cNvCxnSpPr>
            <p:nvPr/>
          </p:nvCxnSpPr>
          <p:spPr>
            <a:xfrm>
              <a:off x="1249848" y="14111211"/>
              <a:ext cx="16907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30" name="Picture 329">
              <a:extLst>
                <a:ext uri="{FF2B5EF4-FFF2-40B4-BE49-F238E27FC236}">
                  <a16:creationId xmlns:a16="http://schemas.microsoft.com/office/drawing/2014/main" id="{D6A03604-34A3-03EA-2D77-141C87228027}"/>
                </a:ext>
              </a:extLst>
            </p:cNvPr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2" t="75938" r="68333" b="18535"/>
            <a:stretch/>
          </p:blipFill>
          <p:spPr bwMode="auto">
            <a:xfrm>
              <a:off x="1500314" y="14433036"/>
              <a:ext cx="2187360" cy="529875"/>
            </a:xfrm>
            <a:prstGeom prst="rect">
              <a:avLst/>
            </a:prstGeom>
            <a:noFill/>
          </p:spPr>
        </p:pic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243B73CA-F24E-6477-EF46-60E2274B2CB3}"/>
                </a:ext>
              </a:extLst>
            </p:cNvPr>
            <p:cNvSpPr txBox="1"/>
            <p:nvPr/>
          </p:nvSpPr>
          <p:spPr>
            <a:xfrm>
              <a:off x="3740506" y="14603662"/>
              <a:ext cx="1857477" cy="264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M2 (M2)</a:t>
              </a:r>
            </a:p>
          </p:txBody>
        </p:sp>
        <p:sp>
          <p:nvSpPr>
            <p:cNvPr id="333" name="Rectangle 332">
              <a:extLst>
                <a:ext uri="{FF2B5EF4-FFF2-40B4-BE49-F238E27FC236}">
                  <a16:creationId xmlns:a16="http://schemas.microsoft.com/office/drawing/2014/main" id="{18D59082-8C60-DC2D-757B-BCA83ECFC833}"/>
                </a:ext>
              </a:extLst>
            </p:cNvPr>
            <p:cNvSpPr/>
            <p:nvPr/>
          </p:nvSpPr>
          <p:spPr>
            <a:xfrm>
              <a:off x="1492360" y="14440596"/>
              <a:ext cx="2182453" cy="500021"/>
            </a:xfrm>
            <a:prstGeom prst="rect">
              <a:avLst/>
            </a:prstGeom>
            <a:noFill/>
            <a:ln w="317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6" name="Straight Connector 335">
              <a:extLst>
                <a:ext uri="{FF2B5EF4-FFF2-40B4-BE49-F238E27FC236}">
                  <a16:creationId xmlns:a16="http://schemas.microsoft.com/office/drawing/2014/main" id="{4ABADDBA-8372-1BD5-3573-83555DA9BCB2}"/>
                </a:ext>
              </a:extLst>
            </p:cNvPr>
            <p:cNvCxnSpPr>
              <a:cxnSpLocks/>
            </p:cNvCxnSpPr>
            <p:nvPr/>
          </p:nvCxnSpPr>
          <p:spPr>
            <a:xfrm>
              <a:off x="1249848" y="14622458"/>
              <a:ext cx="16907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50" name="Picture 349">
              <a:extLst>
                <a:ext uri="{FF2B5EF4-FFF2-40B4-BE49-F238E27FC236}">
                  <a16:creationId xmlns:a16="http://schemas.microsoft.com/office/drawing/2014/main" id="{9C5D8FCE-2A09-2953-B8BE-D95A1B62AB9A}"/>
                </a:ext>
              </a:extLst>
            </p:cNvPr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2" t="82794" r="68333" b="14259"/>
            <a:stretch/>
          </p:blipFill>
          <p:spPr bwMode="auto">
            <a:xfrm>
              <a:off x="1485313" y="15002346"/>
              <a:ext cx="2187360" cy="282554"/>
            </a:xfrm>
            <a:prstGeom prst="rect">
              <a:avLst/>
            </a:prstGeom>
            <a:noFill/>
          </p:spPr>
        </p:pic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5E038C81-5DF4-0A74-187E-AB531B7E73BA}"/>
                </a:ext>
              </a:extLst>
            </p:cNvPr>
            <p:cNvSpPr txBox="1"/>
            <p:nvPr/>
          </p:nvSpPr>
          <p:spPr>
            <a:xfrm>
              <a:off x="3740506" y="15012626"/>
              <a:ext cx="1857477" cy="264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OS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M1)</a:t>
              </a:r>
            </a:p>
          </p:txBody>
        </p:sp>
        <p:sp>
          <p:nvSpPr>
            <p:cNvPr id="353" name="Rectangle 352">
              <a:extLst>
                <a:ext uri="{FF2B5EF4-FFF2-40B4-BE49-F238E27FC236}">
                  <a16:creationId xmlns:a16="http://schemas.microsoft.com/office/drawing/2014/main" id="{2E34F04B-4F72-08BC-F652-71347508AE5E}"/>
                </a:ext>
              </a:extLst>
            </p:cNvPr>
            <p:cNvSpPr/>
            <p:nvPr/>
          </p:nvSpPr>
          <p:spPr>
            <a:xfrm>
              <a:off x="1491728" y="15002345"/>
              <a:ext cx="2183085" cy="282555"/>
            </a:xfrm>
            <a:prstGeom prst="rect">
              <a:avLst/>
            </a:prstGeom>
            <a:noFill/>
            <a:ln w="317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4" name="Straight Connector 353">
              <a:extLst>
                <a:ext uri="{FF2B5EF4-FFF2-40B4-BE49-F238E27FC236}">
                  <a16:creationId xmlns:a16="http://schemas.microsoft.com/office/drawing/2014/main" id="{681D27ED-FBE2-8D4A-249C-1610FFA48382}"/>
                </a:ext>
              </a:extLst>
            </p:cNvPr>
            <p:cNvCxnSpPr>
              <a:cxnSpLocks/>
            </p:cNvCxnSpPr>
            <p:nvPr/>
          </p:nvCxnSpPr>
          <p:spPr>
            <a:xfrm>
              <a:off x="1249848" y="15067718"/>
              <a:ext cx="16907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55" name="Picture 354">
              <a:extLst>
                <a:ext uri="{FF2B5EF4-FFF2-40B4-BE49-F238E27FC236}">
                  <a16:creationId xmlns:a16="http://schemas.microsoft.com/office/drawing/2014/main" id="{5A73EEA8-A037-451C-3CEA-E6BA7D1E324D}"/>
                </a:ext>
              </a:extLst>
            </p:cNvPr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2" t="86961" r="68333" b="7658"/>
            <a:stretch/>
          </p:blipFill>
          <p:spPr bwMode="auto">
            <a:xfrm>
              <a:off x="1499916" y="15338734"/>
              <a:ext cx="2187360" cy="515934"/>
            </a:xfrm>
            <a:prstGeom prst="rect">
              <a:avLst/>
            </a:prstGeom>
            <a:noFill/>
          </p:spPr>
        </p:pic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A596141F-2EB9-5E76-23B4-D798ECC924F9}"/>
                </a:ext>
              </a:extLst>
            </p:cNvPr>
            <p:cNvSpPr txBox="1"/>
            <p:nvPr/>
          </p:nvSpPr>
          <p:spPr>
            <a:xfrm>
              <a:off x="3727879" y="15494236"/>
              <a:ext cx="1857477" cy="264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OCS3 (M1)</a:t>
              </a:r>
            </a:p>
          </p:txBody>
        </p:sp>
        <p:sp>
          <p:nvSpPr>
            <p:cNvPr id="367" name="Rectangle 366">
              <a:extLst>
                <a:ext uri="{FF2B5EF4-FFF2-40B4-BE49-F238E27FC236}">
                  <a16:creationId xmlns:a16="http://schemas.microsoft.com/office/drawing/2014/main" id="{AA380D93-9B2F-036E-B3A2-9497824CA221}"/>
                </a:ext>
              </a:extLst>
            </p:cNvPr>
            <p:cNvSpPr/>
            <p:nvPr/>
          </p:nvSpPr>
          <p:spPr>
            <a:xfrm>
              <a:off x="1497499" y="15339231"/>
              <a:ext cx="2182453" cy="500021"/>
            </a:xfrm>
            <a:prstGeom prst="rect">
              <a:avLst/>
            </a:prstGeom>
            <a:noFill/>
            <a:ln w="317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8" name="Straight Connector 367">
              <a:extLst>
                <a:ext uri="{FF2B5EF4-FFF2-40B4-BE49-F238E27FC236}">
                  <a16:creationId xmlns:a16="http://schemas.microsoft.com/office/drawing/2014/main" id="{4463BCA3-173A-4722-E068-6B61363D0AB0}"/>
                </a:ext>
              </a:extLst>
            </p:cNvPr>
            <p:cNvCxnSpPr>
              <a:cxnSpLocks/>
            </p:cNvCxnSpPr>
            <p:nvPr/>
          </p:nvCxnSpPr>
          <p:spPr>
            <a:xfrm>
              <a:off x="1249848" y="15613800"/>
              <a:ext cx="16907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9" name="Group 368">
              <a:extLst>
                <a:ext uri="{FF2B5EF4-FFF2-40B4-BE49-F238E27FC236}">
                  <a16:creationId xmlns:a16="http://schemas.microsoft.com/office/drawing/2014/main" id="{2595F909-1A97-78C1-5E73-81F71AEB248F}"/>
                </a:ext>
              </a:extLst>
            </p:cNvPr>
            <p:cNvGrpSpPr/>
            <p:nvPr/>
          </p:nvGrpSpPr>
          <p:grpSpPr>
            <a:xfrm>
              <a:off x="905664" y="13988531"/>
              <a:ext cx="4749889" cy="2350873"/>
              <a:chOff x="1435492" y="13738005"/>
              <a:chExt cx="4749889" cy="2350873"/>
            </a:xfrm>
          </p:grpSpPr>
          <p:sp>
            <p:nvSpPr>
              <p:cNvPr id="370" name="TextBox 369">
                <a:extLst>
                  <a:ext uri="{FF2B5EF4-FFF2-40B4-BE49-F238E27FC236}">
                    <a16:creationId xmlns:a16="http://schemas.microsoft.com/office/drawing/2014/main" id="{2326590C-7CE1-4AF4-B92B-03B2C7E05B42}"/>
                  </a:ext>
                </a:extLst>
              </p:cNvPr>
              <p:cNvSpPr txBox="1"/>
              <p:nvPr/>
            </p:nvSpPr>
            <p:spPr>
              <a:xfrm>
                <a:off x="1490783" y="13738005"/>
                <a:ext cx="578701" cy="264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371" name="TextBox 370">
                <a:extLst>
                  <a:ext uri="{FF2B5EF4-FFF2-40B4-BE49-F238E27FC236}">
                    <a16:creationId xmlns:a16="http://schemas.microsoft.com/office/drawing/2014/main" id="{45135696-F42C-BC0D-BADF-B296DB8E9AEC}"/>
                  </a:ext>
                </a:extLst>
              </p:cNvPr>
              <p:cNvSpPr txBox="1"/>
              <p:nvPr/>
            </p:nvSpPr>
            <p:spPr>
              <a:xfrm>
                <a:off x="1516016" y="14236921"/>
                <a:ext cx="580817" cy="264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372" name="TextBox 371">
                <a:extLst>
                  <a:ext uri="{FF2B5EF4-FFF2-40B4-BE49-F238E27FC236}">
                    <a16:creationId xmlns:a16="http://schemas.microsoft.com/office/drawing/2014/main" id="{D51274A5-C4ED-843F-6ED0-EA466F7BD039}"/>
                  </a:ext>
                </a:extLst>
              </p:cNvPr>
              <p:cNvSpPr txBox="1"/>
              <p:nvPr/>
            </p:nvSpPr>
            <p:spPr>
              <a:xfrm>
                <a:off x="1435492" y="14695676"/>
                <a:ext cx="2623381" cy="264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373" name="TextBox 372">
                <a:extLst>
                  <a:ext uri="{FF2B5EF4-FFF2-40B4-BE49-F238E27FC236}">
                    <a16:creationId xmlns:a16="http://schemas.microsoft.com/office/drawing/2014/main" id="{1BEC3238-936B-73B7-36A6-57BA2D27F68C}"/>
                  </a:ext>
                </a:extLst>
              </p:cNvPr>
              <p:cNvSpPr txBox="1"/>
              <p:nvPr/>
            </p:nvSpPr>
            <p:spPr>
              <a:xfrm>
                <a:off x="1493883" y="15227924"/>
                <a:ext cx="681362" cy="264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grpSp>
            <p:nvGrpSpPr>
              <p:cNvPr id="374" name="Group 373">
                <a:extLst>
                  <a:ext uri="{FF2B5EF4-FFF2-40B4-BE49-F238E27FC236}">
                    <a16:creationId xmlns:a16="http://schemas.microsoft.com/office/drawing/2014/main" id="{84A889E6-5BC4-9DBF-8CCB-4E584C8D86D0}"/>
                  </a:ext>
                </a:extLst>
              </p:cNvPr>
              <p:cNvGrpSpPr/>
              <p:nvPr/>
            </p:nvGrpSpPr>
            <p:grpSpPr>
              <a:xfrm>
                <a:off x="1496434" y="15643216"/>
                <a:ext cx="4688947" cy="445662"/>
                <a:chOff x="4801272" y="6111420"/>
                <a:chExt cx="3194025" cy="281008"/>
              </a:xfrm>
            </p:grpSpPr>
            <p:pic>
              <p:nvPicPr>
                <p:cNvPr id="375" name="Picture 374">
                  <a:extLst>
                    <a:ext uri="{FF2B5EF4-FFF2-40B4-BE49-F238E27FC236}">
                      <a16:creationId xmlns:a16="http://schemas.microsoft.com/office/drawing/2014/main" id="{A23CF54E-BA92-1B4F-BD6A-619A7B4104B3}"/>
                    </a:ext>
                  </a:extLst>
                </p:cNvPr>
                <p:cNvPicPr/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42" t="93289" r="68661" b="2099"/>
                <a:stretch/>
              </p:blipFill>
              <p:spPr bwMode="auto">
                <a:xfrm>
                  <a:off x="5174435" y="6116512"/>
                  <a:ext cx="1489991" cy="221576"/>
                </a:xfrm>
                <a:prstGeom prst="rect">
                  <a:avLst/>
                </a:prstGeom>
                <a:noFill/>
              </p:spPr>
            </p:pic>
            <p:sp>
              <p:nvSpPr>
                <p:cNvPr id="376" name="TextBox 375">
                  <a:extLst>
                    <a:ext uri="{FF2B5EF4-FFF2-40B4-BE49-F238E27FC236}">
                      <a16:creationId xmlns:a16="http://schemas.microsoft.com/office/drawing/2014/main" id="{210B52F8-801A-BDF4-D0D3-4AE5D7C4E09C}"/>
                    </a:ext>
                  </a:extLst>
                </p:cNvPr>
                <p:cNvSpPr txBox="1"/>
                <p:nvPr/>
              </p:nvSpPr>
              <p:spPr>
                <a:xfrm>
                  <a:off x="6730019" y="6153725"/>
                  <a:ext cx="1265278" cy="1666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tin</a:t>
                  </a:r>
                </a:p>
              </p:txBody>
            </p:sp>
            <p:sp>
              <p:nvSpPr>
                <p:cNvPr id="377" name="Rectangle 376">
                  <a:extLst>
                    <a:ext uri="{FF2B5EF4-FFF2-40B4-BE49-F238E27FC236}">
                      <a16:creationId xmlns:a16="http://schemas.microsoft.com/office/drawing/2014/main" id="{7F1F48E1-1D6F-6254-3FCB-FBF3D85A0E3B}"/>
                    </a:ext>
                  </a:extLst>
                </p:cNvPr>
                <p:cNvSpPr/>
                <p:nvPr/>
              </p:nvSpPr>
              <p:spPr>
                <a:xfrm>
                  <a:off x="5162679" y="6111420"/>
                  <a:ext cx="1491360" cy="226668"/>
                </a:xfrm>
                <a:prstGeom prst="rect">
                  <a:avLst/>
                </a:prstGeom>
                <a:noFill/>
                <a:ln w="317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" name="TextBox 377">
                  <a:extLst>
                    <a:ext uri="{FF2B5EF4-FFF2-40B4-BE49-F238E27FC236}">
                      <a16:creationId xmlns:a16="http://schemas.microsoft.com/office/drawing/2014/main" id="{1BDB47E5-94D9-EDB0-810A-C203AB4AE1B2}"/>
                    </a:ext>
                  </a:extLst>
                </p:cNvPr>
                <p:cNvSpPr txBox="1"/>
                <p:nvPr/>
              </p:nvSpPr>
              <p:spPr>
                <a:xfrm>
                  <a:off x="4801272" y="6225827"/>
                  <a:ext cx="368388" cy="1666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cxnSp>
              <p:nvCxnSpPr>
                <p:cNvPr id="381" name="Straight Connector 380">
                  <a:extLst>
                    <a:ext uri="{FF2B5EF4-FFF2-40B4-BE49-F238E27FC236}">
                      <a16:creationId xmlns:a16="http://schemas.microsoft.com/office/drawing/2014/main" id="{C080B667-E0A3-F6C3-8C34-6A08A04DD3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08362" y="6302130"/>
                  <a:ext cx="115172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2321588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09</TotalTime>
  <Words>290</Words>
  <Application>Microsoft Office PowerPoint</Application>
  <PresentationFormat>Custom</PresentationFormat>
  <Paragraphs>5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University of Cincinna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ynak, Ahmet (kaynakat)</dc:creator>
  <cp:lastModifiedBy>Kaynak, Ahmet (kaynakat)</cp:lastModifiedBy>
  <cp:revision>24</cp:revision>
  <cp:lastPrinted>2024-11-15T14:36:32Z</cp:lastPrinted>
  <dcterms:created xsi:type="dcterms:W3CDTF">2024-11-06T15:34:08Z</dcterms:created>
  <dcterms:modified xsi:type="dcterms:W3CDTF">2025-03-28T17:59:54Z</dcterms:modified>
</cp:coreProperties>
</file>